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76" r:id="rId2"/>
  </p:sldIdLst>
  <p:sldSz cx="9144000" cy="12192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  <a:srgbClr val="000000"/>
    <a:srgbClr val="800000"/>
    <a:srgbClr val="FF5050"/>
    <a:srgbClr val="660033"/>
    <a:srgbClr val="A5002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12" autoAdjust="0"/>
    <p:restoredTop sz="94182" autoAdjust="0"/>
  </p:normalViewPr>
  <p:slideViewPr>
    <p:cSldViewPr snapToGrid="0">
      <p:cViewPr varScale="1">
        <p:scale>
          <a:sx n="48" d="100"/>
          <a:sy n="48" d="100"/>
        </p:scale>
        <p:origin x="1668" y="96"/>
      </p:cViewPr>
      <p:guideLst>
        <p:guide orient="horz" pos="384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24" Type="http://schemas.microsoft.com/office/2015/10/relationships/revisionInfo" Target="revisionInfo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DB5401-9E50-4A41-A60F-9F30E0AF832B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61E759-6D05-4F29-BC5C-714080C845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172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61E759-6D05-4F29-BC5C-714080C845B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48184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95312"/>
            <a:ext cx="7772400" cy="424462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403623"/>
            <a:ext cx="6858000" cy="294357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7941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8480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49111"/>
            <a:ext cx="1971675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49111"/>
            <a:ext cx="5800725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0185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7811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039537"/>
            <a:ext cx="7886700" cy="507153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159048"/>
            <a:ext cx="7886700" cy="26669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6019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245556"/>
            <a:ext cx="388620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245556"/>
            <a:ext cx="388620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170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49114"/>
            <a:ext cx="7886700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988734"/>
            <a:ext cx="3868340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453467"/>
            <a:ext cx="3868340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988734"/>
            <a:ext cx="3887391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453467"/>
            <a:ext cx="3887391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8957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0097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2880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755425"/>
            <a:ext cx="4629150" cy="866422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1288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755425"/>
            <a:ext cx="4629150" cy="8664222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1697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49114"/>
            <a:ext cx="78867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245556"/>
            <a:ext cx="78867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BD4E6-D7A7-4F39-BFC7-BD44164BF8E5}" type="datetimeFigureOut">
              <a:rPr lang="zh-CN" altLang="en-US" smtClean="0"/>
              <a:t>2018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300181"/>
            <a:ext cx="30861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82DD02-EA4B-4BF5-92E8-96B766637C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2573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openxmlformats.org/officeDocument/2006/relationships/image" Target="../media/image10.tiff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9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emf"/><Relationship Id="rId10" Type="http://schemas.microsoft.com/office/2007/relationships/hdphoto" Target="../media/hdphoto4.wdp"/><Relationship Id="rId19" Type="http://schemas.openxmlformats.org/officeDocument/2006/relationships/image" Target="../media/image11.tiff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文本框 25"/>
          <p:cNvSpPr txBox="1"/>
          <p:nvPr/>
        </p:nvSpPr>
        <p:spPr>
          <a:xfrm rot="16200000">
            <a:off x="5331808" y="2024929"/>
            <a:ext cx="1087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 rot="16200000">
            <a:off x="4934505" y="3910175"/>
            <a:ext cx="1854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0.1uM DOX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-63954" y="-97911"/>
            <a:ext cx="4578497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3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zh-CN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103601" y="494474"/>
            <a:ext cx="44435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矩形 38"/>
          <p:cNvSpPr/>
          <p:nvPr/>
        </p:nvSpPr>
        <p:spPr>
          <a:xfrm>
            <a:off x="5030638" y="494474"/>
            <a:ext cx="44435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8" name="组合 17"/>
          <p:cNvGrpSpPr/>
          <p:nvPr/>
        </p:nvGrpSpPr>
        <p:grpSpPr>
          <a:xfrm>
            <a:off x="194120" y="7959450"/>
            <a:ext cx="4088215" cy="1286735"/>
            <a:chOff x="3195279" y="6977667"/>
            <a:chExt cx="3996442" cy="1472412"/>
          </a:xfrm>
        </p:grpSpPr>
        <p:sp>
          <p:nvSpPr>
            <p:cNvPr id="10" name="文本框 9"/>
            <p:cNvSpPr txBox="1"/>
            <p:nvPr/>
          </p:nvSpPr>
          <p:spPr>
            <a:xfrm>
              <a:off x="3195279" y="8027452"/>
              <a:ext cx="1273193" cy="4226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3261761" y="7556561"/>
              <a:ext cx="1199690" cy="4226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Sirt3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4522120" y="7011734"/>
              <a:ext cx="656687" cy="4226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5584412" y="6977667"/>
              <a:ext cx="1607309" cy="42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0" name="矩形 39"/>
          <p:cNvSpPr/>
          <p:nvPr/>
        </p:nvSpPr>
        <p:spPr>
          <a:xfrm>
            <a:off x="39953" y="5859737"/>
            <a:ext cx="44435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1" name="矩形 40"/>
          <p:cNvSpPr/>
          <p:nvPr/>
        </p:nvSpPr>
        <p:spPr>
          <a:xfrm>
            <a:off x="43721" y="7801166"/>
            <a:ext cx="44435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2" name="矩形 41"/>
          <p:cNvSpPr/>
          <p:nvPr/>
        </p:nvSpPr>
        <p:spPr>
          <a:xfrm>
            <a:off x="5231184" y="7833334"/>
            <a:ext cx="42351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30" name="组合 29"/>
          <p:cNvGrpSpPr/>
          <p:nvPr/>
        </p:nvGrpSpPr>
        <p:grpSpPr>
          <a:xfrm>
            <a:off x="715006" y="1014145"/>
            <a:ext cx="3977859" cy="1742181"/>
            <a:chOff x="715006" y="694105"/>
            <a:chExt cx="3977859" cy="1742181"/>
          </a:xfrm>
        </p:grpSpPr>
        <p:grpSp>
          <p:nvGrpSpPr>
            <p:cNvPr id="21" name="组合 20"/>
            <p:cNvGrpSpPr/>
            <p:nvPr/>
          </p:nvGrpSpPr>
          <p:grpSpPr>
            <a:xfrm>
              <a:off x="715006" y="694105"/>
              <a:ext cx="3977859" cy="1742181"/>
              <a:chOff x="715006" y="694105"/>
              <a:chExt cx="3977859" cy="1742181"/>
            </a:xfrm>
          </p:grpSpPr>
          <p:grpSp>
            <p:nvGrpSpPr>
              <p:cNvPr id="2" name="组合 1"/>
              <p:cNvGrpSpPr/>
              <p:nvPr/>
            </p:nvGrpSpPr>
            <p:grpSpPr>
              <a:xfrm>
                <a:off x="715006" y="694105"/>
                <a:ext cx="3977859" cy="1742181"/>
                <a:chOff x="920140" y="735732"/>
                <a:chExt cx="3977859" cy="1742181"/>
              </a:xfrm>
            </p:grpSpPr>
            <p:pic>
              <p:nvPicPr>
                <p:cNvPr id="38" name="图片 37"/>
                <p:cNvPicPr>
                  <a:picLocks/>
                </p:cNvPicPr>
                <p:nvPr/>
              </p:nvPicPr>
              <p:blipFill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20140" y="742713"/>
                  <a:ext cx="1962000" cy="1735200"/>
                </a:xfrm>
                <a:prstGeom prst="rect">
                  <a:avLst/>
                </a:prstGeom>
              </p:spPr>
            </p:pic>
            <p:pic>
              <p:nvPicPr>
                <p:cNvPr id="22" name="图片 21"/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934393" y="735732"/>
                  <a:ext cx="1963606" cy="1736571"/>
                </a:xfrm>
                <a:prstGeom prst="rect">
                  <a:avLst/>
                </a:prstGeom>
              </p:spPr>
            </p:pic>
          </p:grpSp>
          <p:cxnSp>
            <p:nvCxnSpPr>
              <p:cNvPr id="45" name="直接连接符 44"/>
              <p:cNvCxnSpPr/>
              <p:nvPr/>
            </p:nvCxnSpPr>
            <p:spPr>
              <a:xfrm>
                <a:off x="830106" y="2343060"/>
                <a:ext cx="234000" cy="0"/>
              </a:xfrm>
              <a:prstGeom prst="line">
                <a:avLst/>
              </a:prstGeom>
              <a:ln w="1270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接连接符 47"/>
              <p:cNvCxnSpPr/>
              <p:nvPr/>
            </p:nvCxnSpPr>
            <p:spPr>
              <a:xfrm>
                <a:off x="2839256" y="2343060"/>
                <a:ext cx="234000" cy="0"/>
              </a:xfrm>
              <a:prstGeom prst="line">
                <a:avLst/>
              </a:prstGeom>
              <a:ln w="1270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9" name="文本框 28"/>
            <p:cNvSpPr txBox="1"/>
            <p:nvPr/>
          </p:nvSpPr>
          <p:spPr>
            <a:xfrm>
              <a:off x="729020" y="2134840"/>
              <a:ext cx="5867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2729259" y="2134840"/>
              <a:ext cx="5867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6201585" y="1248403"/>
            <a:ext cx="2234473" cy="1976120"/>
            <a:chOff x="5879018" y="828973"/>
            <a:chExt cx="2234473" cy="1976120"/>
          </a:xfrm>
        </p:grpSpPr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79018" y="828973"/>
              <a:ext cx="2234473" cy="1976120"/>
            </a:xfrm>
            <a:prstGeom prst="rect">
              <a:avLst/>
            </a:prstGeom>
          </p:spPr>
        </p:pic>
        <p:cxnSp>
          <p:nvCxnSpPr>
            <p:cNvPr id="46" name="直接连接符 45"/>
            <p:cNvCxnSpPr/>
            <p:nvPr/>
          </p:nvCxnSpPr>
          <p:spPr>
            <a:xfrm>
              <a:off x="5996855" y="2684139"/>
              <a:ext cx="48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文本框 49"/>
            <p:cNvSpPr txBox="1"/>
            <p:nvPr/>
          </p:nvSpPr>
          <p:spPr>
            <a:xfrm>
              <a:off x="5946483" y="2422528"/>
              <a:ext cx="5867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US" altLang="zh-CN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组合 3"/>
          <p:cNvGrpSpPr/>
          <p:nvPr/>
        </p:nvGrpSpPr>
        <p:grpSpPr>
          <a:xfrm>
            <a:off x="6211524" y="3236636"/>
            <a:ext cx="2234473" cy="1976120"/>
            <a:chOff x="5879018" y="2992796"/>
            <a:chExt cx="2234473" cy="1976120"/>
          </a:xfrm>
        </p:grpSpPr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79018" y="2992796"/>
              <a:ext cx="2234473" cy="1976120"/>
            </a:xfrm>
            <a:prstGeom prst="rect">
              <a:avLst/>
            </a:prstGeom>
          </p:spPr>
        </p:pic>
        <p:cxnSp>
          <p:nvCxnSpPr>
            <p:cNvPr id="47" name="直接连接符 46"/>
            <p:cNvCxnSpPr/>
            <p:nvPr/>
          </p:nvCxnSpPr>
          <p:spPr>
            <a:xfrm>
              <a:off x="6037877" y="4847962"/>
              <a:ext cx="48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文本框 50"/>
            <p:cNvSpPr txBox="1"/>
            <p:nvPr/>
          </p:nvSpPr>
          <p:spPr>
            <a:xfrm>
              <a:off x="5987505" y="4586351"/>
              <a:ext cx="5867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US" altLang="zh-CN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组合 18"/>
          <p:cNvGrpSpPr/>
          <p:nvPr/>
        </p:nvGrpSpPr>
        <p:grpSpPr>
          <a:xfrm>
            <a:off x="609758" y="6052494"/>
            <a:ext cx="5893571" cy="1671985"/>
            <a:chOff x="1757085" y="6137667"/>
            <a:chExt cx="5893571" cy="1671985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0303" y="6139422"/>
              <a:ext cx="2930353" cy="1668894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57085" y="6137667"/>
              <a:ext cx="2935780" cy="1671985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1862363" y="6172162"/>
              <a:ext cx="12108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zh-CN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4793338" y="6172162"/>
              <a:ext cx="21135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t3-ShRNA</a:t>
              </a:r>
              <a:endParaRPr lang="zh-CN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4" name="组合 53"/>
            <p:cNvGrpSpPr/>
            <p:nvPr/>
          </p:nvGrpSpPr>
          <p:grpSpPr>
            <a:xfrm>
              <a:off x="4813474" y="7513716"/>
              <a:ext cx="586744" cy="230832"/>
              <a:chOff x="4829240" y="7760853"/>
              <a:chExt cx="586744" cy="230832"/>
            </a:xfrm>
          </p:grpSpPr>
          <p:sp>
            <p:nvSpPr>
              <p:cNvPr id="52" name="文本框 51"/>
              <p:cNvSpPr txBox="1"/>
              <p:nvPr/>
            </p:nvSpPr>
            <p:spPr>
              <a:xfrm>
                <a:off x="4829240" y="7760853"/>
                <a:ext cx="58674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altLang="zh-CN" sz="900" dirty="0" err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m</a:t>
                </a:r>
                <a:endParaRPr lang="zh-CN" alt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3" name="直接连接符 52"/>
              <p:cNvCxnSpPr/>
              <p:nvPr/>
            </p:nvCxnSpPr>
            <p:spPr>
              <a:xfrm>
                <a:off x="4929404" y="7984074"/>
                <a:ext cx="2340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5" name="组合 54"/>
            <p:cNvGrpSpPr/>
            <p:nvPr/>
          </p:nvGrpSpPr>
          <p:grpSpPr>
            <a:xfrm>
              <a:off x="1823398" y="7513716"/>
              <a:ext cx="586744" cy="230832"/>
              <a:chOff x="4829240" y="7760853"/>
              <a:chExt cx="586744" cy="230832"/>
            </a:xfrm>
          </p:grpSpPr>
          <p:sp>
            <p:nvSpPr>
              <p:cNvPr id="56" name="文本框 55"/>
              <p:cNvSpPr txBox="1"/>
              <p:nvPr/>
            </p:nvSpPr>
            <p:spPr>
              <a:xfrm>
                <a:off x="4829240" y="7760853"/>
                <a:ext cx="58674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altLang="zh-CN" sz="900" dirty="0" err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m</a:t>
                </a:r>
                <a:endParaRPr lang="zh-CN" alt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7" name="直接连接符 56"/>
              <p:cNvCxnSpPr/>
              <p:nvPr/>
            </p:nvCxnSpPr>
            <p:spPr>
              <a:xfrm>
                <a:off x="4929404" y="7984074"/>
                <a:ext cx="2340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8" name="矩形 57"/>
          <p:cNvSpPr/>
          <p:nvPr/>
        </p:nvSpPr>
        <p:spPr>
          <a:xfrm>
            <a:off x="3776803" y="8496910"/>
            <a:ext cx="82105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44KD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3795822" y="8942110"/>
            <a:ext cx="82105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-63954" y="2607643"/>
            <a:ext cx="5236074" cy="3122564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67760" y="9121133"/>
            <a:ext cx="3754856" cy="3113421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923646" y="8958727"/>
            <a:ext cx="4306503" cy="3230764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89" t="28073" r="4815" b="30083"/>
          <a:stretch/>
        </p:blipFill>
        <p:spPr>
          <a:xfrm>
            <a:off x="1469009" y="8511119"/>
            <a:ext cx="2152357" cy="3235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图片 27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9" t="17771" r="6555" b="20373"/>
          <a:stretch/>
        </p:blipFill>
        <p:spPr>
          <a:xfrm>
            <a:off x="1477335" y="8876853"/>
            <a:ext cx="2124222" cy="47830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86506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>
          <a:tailEnd type="triangl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98</TotalTime>
  <Words>32</Words>
  <Application>Microsoft Office PowerPoint</Application>
  <PresentationFormat>自定义</PresentationFormat>
  <Paragraphs>2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i YI</dc:creator>
  <cp:lastModifiedBy>Sigmazdj</cp:lastModifiedBy>
  <cp:revision>559</cp:revision>
  <dcterms:created xsi:type="dcterms:W3CDTF">2015-11-04T08:50:29Z</dcterms:created>
  <dcterms:modified xsi:type="dcterms:W3CDTF">2018-01-28T17:26:47Z</dcterms:modified>
</cp:coreProperties>
</file>